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92AC9-1783-4049-BC87-D5FB302597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B5FA4-CDE2-496E-9212-1CC5022FE1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DA371-D379-4873-BB66-7B3C172261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7535F-EC7A-48DF-957D-F3FBCC5F18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E51F6-8DB4-4FA2-B91A-5B6077361A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F374E-088A-42A4-BC36-2A52DA27FF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E00B7-673F-4156-B2D5-BC50DD6EC2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CAC6E-E1D7-4B85-9720-27B9C3D7F8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93911-440B-48D9-9710-6431CDF0D2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E422A-BFFE-4E03-8D98-8FBD44D519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6F70F-1A62-40BF-BCF4-65B3D380DF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89266-F657-4187-BBE1-C0F1A6AAB6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F03F2E-33A4-44F9-85AF-AE37FFB62F7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493560" y="527040"/>
            <a:ext cx="7369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3. No correlation between age at report and telomere length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ge at report versus telomere length of index cases in different genetic subtypes, as indicated on each pane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9"/>
          <p:cNvSpPr/>
          <p:nvPr/>
        </p:nvSpPr>
        <p:spPr>
          <a:xfrm>
            <a:off x="1593000" y="345132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DKC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0"/>
          <p:cNvSpPr/>
          <p:nvPr/>
        </p:nvSpPr>
        <p:spPr>
          <a:xfrm>
            <a:off x="1483200" y="621972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1"/>
          <p:cNvSpPr/>
          <p:nvPr/>
        </p:nvSpPr>
        <p:spPr>
          <a:xfrm>
            <a:off x="5817240" y="3389400"/>
            <a:ext cx="67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TINF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2"/>
          <p:cNvSpPr/>
          <p:nvPr/>
        </p:nvSpPr>
        <p:spPr>
          <a:xfrm>
            <a:off x="5511960" y="620568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TER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44560" y="1441440"/>
            <a:ext cx="0" cy="2278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819000" y="371952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819000" y="346860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19000" y="320976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19000" y="296064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19000" y="270972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19000" y="245124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819000" y="220032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19000" y="195120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19000" y="169236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819000" y="144144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844560" y="1441440"/>
            <a:ext cx="3260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844560" y="144108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1495440" y="144108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2144880" y="144108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2805120" y="144108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3454560" y="144108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4105440" y="144108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436840" y="217656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170080" y="247644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370240" y="20844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778040" y="218448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236680" y="207648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452600" y="179244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844640" y="165888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328760" y="20844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562120" y="265104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585800" y="215892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585800" y="247644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936720" y="16416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346560" y="265896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519200" y="24354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993600" y="251784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993600" y="193356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236680" y="206676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044800" y="299412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519200" y="270180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386000" y="265104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28600" y="266868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993600" y="289404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103480" y="26100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70120" y="298440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328760" y="255096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452600" y="148428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170080" y="227664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911240" y="142560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021120" y="299412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303640" y="279252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585800" y="241776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328760" y="210996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262160" y="282564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128600" y="282564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978200" y="210996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452600" y="199224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870120" y="20178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778040" y="229248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711440" y="182556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585800" y="288432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452600" y="262584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870120" y="280980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103480" y="28512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060560" y="303516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386000" y="258444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213000" y="273528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936720" y="230976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060560" y="306072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585800" y="2784600"/>
            <a:ext cx="9072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346560" y="195120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778040" y="207648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452600" y="186696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2370240" y="2701800"/>
            <a:ext cx="9036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413160" y="200988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128600" y="1574640"/>
            <a:ext cx="90720" cy="9072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262160" y="3384720"/>
            <a:ext cx="90360" cy="90360"/>
          </a:xfrm>
          <a:prstGeom prst="ellipse">
            <a:avLst/>
          </a:prstGeom>
          <a:solidFill>
            <a:srgbClr val="cc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7640" bIns="17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911160" y="2384280"/>
            <a:ext cx="2543400" cy="66960"/>
          </a:xfrm>
          <a:custGeom>
            <a:avLst/>
            <a:gdLst/>
            <a:ahLst/>
            <a:rect l="l" t="t" r="r" b="b"/>
            <a:pathLst>
              <a:path w="305" h="8">
                <a:moveTo>
                  <a:pt x="0" y="8"/>
                </a:moveTo>
                <a:lnTo>
                  <a:pt x="5" y="8"/>
                </a:lnTo>
                <a:lnTo>
                  <a:pt x="11" y="8"/>
                </a:lnTo>
                <a:lnTo>
                  <a:pt x="16" y="8"/>
                </a:lnTo>
                <a:lnTo>
                  <a:pt x="22" y="8"/>
                </a:lnTo>
                <a:lnTo>
                  <a:pt x="28" y="7"/>
                </a:lnTo>
                <a:lnTo>
                  <a:pt x="33" y="7"/>
                </a:lnTo>
                <a:lnTo>
                  <a:pt x="39" y="7"/>
                </a:lnTo>
                <a:lnTo>
                  <a:pt x="44" y="7"/>
                </a:lnTo>
                <a:lnTo>
                  <a:pt x="50" y="7"/>
                </a:lnTo>
                <a:lnTo>
                  <a:pt x="55" y="7"/>
                </a:lnTo>
                <a:lnTo>
                  <a:pt x="61" y="7"/>
                </a:lnTo>
                <a:lnTo>
                  <a:pt x="66" y="6"/>
                </a:lnTo>
                <a:lnTo>
                  <a:pt x="72" y="6"/>
                </a:lnTo>
                <a:lnTo>
                  <a:pt x="77" y="6"/>
                </a:lnTo>
                <a:lnTo>
                  <a:pt x="83" y="6"/>
                </a:lnTo>
                <a:lnTo>
                  <a:pt x="89" y="6"/>
                </a:lnTo>
                <a:lnTo>
                  <a:pt x="94" y="6"/>
                </a:lnTo>
                <a:lnTo>
                  <a:pt x="100" y="6"/>
                </a:lnTo>
                <a:lnTo>
                  <a:pt x="105" y="5"/>
                </a:lnTo>
                <a:lnTo>
                  <a:pt x="111" y="5"/>
                </a:lnTo>
                <a:lnTo>
                  <a:pt x="116" y="5"/>
                </a:lnTo>
                <a:lnTo>
                  <a:pt x="122" y="5"/>
                </a:lnTo>
                <a:lnTo>
                  <a:pt x="127" y="5"/>
                </a:lnTo>
                <a:lnTo>
                  <a:pt x="133" y="5"/>
                </a:lnTo>
                <a:lnTo>
                  <a:pt x="138" y="5"/>
                </a:lnTo>
                <a:lnTo>
                  <a:pt x="144" y="4"/>
                </a:lnTo>
                <a:lnTo>
                  <a:pt x="150" y="4"/>
                </a:lnTo>
                <a:lnTo>
                  <a:pt x="155" y="4"/>
                </a:lnTo>
                <a:lnTo>
                  <a:pt x="161" y="4"/>
                </a:lnTo>
                <a:lnTo>
                  <a:pt x="166" y="4"/>
                </a:lnTo>
                <a:lnTo>
                  <a:pt x="172" y="4"/>
                </a:lnTo>
                <a:lnTo>
                  <a:pt x="177" y="3"/>
                </a:lnTo>
                <a:lnTo>
                  <a:pt x="183" y="3"/>
                </a:lnTo>
                <a:lnTo>
                  <a:pt x="188" y="3"/>
                </a:lnTo>
                <a:lnTo>
                  <a:pt x="194" y="3"/>
                </a:lnTo>
                <a:lnTo>
                  <a:pt x="199" y="3"/>
                </a:lnTo>
                <a:lnTo>
                  <a:pt x="205" y="3"/>
                </a:lnTo>
                <a:lnTo>
                  <a:pt x="211" y="3"/>
                </a:lnTo>
                <a:lnTo>
                  <a:pt x="216" y="2"/>
                </a:lnTo>
                <a:lnTo>
                  <a:pt x="222" y="2"/>
                </a:lnTo>
                <a:lnTo>
                  <a:pt x="227" y="2"/>
                </a:lnTo>
                <a:lnTo>
                  <a:pt x="233" y="2"/>
                </a:lnTo>
                <a:lnTo>
                  <a:pt x="238" y="2"/>
                </a:lnTo>
                <a:lnTo>
                  <a:pt x="244" y="2"/>
                </a:lnTo>
                <a:lnTo>
                  <a:pt x="249" y="2"/>
                </a:lnTo>
                <a:lnTo>
                  <a:pt x="255" y="1"/>
                </a:lnTo>
                <a:lnTo>
                  <a:pt x="260" y="1"/>
                </a:lnTo>
                <a:lnTo>
                  <a:pt x="266" y="1"/>
                </a:lnTo>
                <a:lnTo>
                  <a:pt x="272" y="1"/>
                </a:lnTo>
                <a:lnTo>
                  <a:pt x="277" y="1"/>
                </a:lnTo>
                <a:lnTo>
                  <a:pt x="283" y="1"/>
                </a:lnTo>
                <a:lnTo>
                  <a:pt x="288" y="0"/>
                </a:lnTo>
                <a:lnTo>
                  <a:pt x="294" y="0"/>
                </a:lnTo>
                <a:lnTo>
                  <a:pt x="299" y="0"/>
                </a:lnTo>
                <a:lnTo>
                  <a:pt x="30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94080" y="36608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94080" y="340992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94080" y="31510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94080" y="290196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694080" y="26510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94080" y="239220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94080" y="21430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94080" y="189216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94080" y="16336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727200" y="13842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819000" y="15177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492200" y="15177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2095560" y="15177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754360" y="15177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405240" y="15177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056120" y="15177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838080" y="4114800"/>
            <a:ext cx="0" cy="2228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814320" y="63435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814320" y="606600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814320" y="57880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814320" y="55119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814320" y="523404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814320" y="49467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814320" y="46702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814320" y="439272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814320" y="411480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838080" y="4114800"/>
            <a:ext cx="3203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V="1">
            <a:off x="83808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flipV="1">
            <a:off x="137016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190800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244008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297036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351000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4041720" y="4114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455920" y="5429160"/>
            <a:ext cx="90360" cy="9072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173240" y="5715000"/>
            <a:ext cx="90360" cy="9036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517920" y="4881600"/>
            <a:ext cx="90360" cy="9036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492200" y="5388120"/>
            <a:ext cx="90360" cy="9036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492200" y="4865760"/>
            <a:ext cx="90360" cy="903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598760" y="5665680"/>
            <a:ext cx="90360" cy="9072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598760" y="5568840"/>
            <a:ext cx="90360" cy="907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960480" y="4670280"/>
            <a:ext cx="90360" cy="907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128680" y="5405400"/>
            <a:ext cx="90720" cy="9036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562120" y="5070600"/>
            <a:ext cx="90720" cy="9036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362400" y="5421240"/>
            <a:ext cx="90360" cy="907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094200" y="4130640"/>
            <a:ext cx="90360" cy="903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26"/>
                </a:lnTo>
                <a:lnTo>
                  <a:pt x="25" y="51"/>
                </a:lnTo>
                <a:lnTo>
                  <a:pt x="0" y="26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292480" y="5805360"/>
            <a:ext cx="90360" cy="9072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960480" y="4325760"/>
            <a:ext cx="90360" cy="9072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811160" y="4915080"/>
            <a:ext cx="90720" cy="903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26"/>
                </a:lnTo>
                <a:lnTo>
                  <a:pt x="25" y="51"/>
                </a:lnTo>
                <a:lnTo>
                  <a:pt x="0" y="26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398680" y="4857840"/>
            <a:ext cx="90360" cy="9036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541520" y="4775040"/>
            <a:ext cx="90360" cy="90720"/>
          </a:xfrm>
          <a:custGeom>
            <a:avLst/>
            <a:gdLst/>
            <a:ahLst/>
            <a:rect l="l" t="t" r="r" b="b"/>
            <a:pathLst>
              <a:path w="51" h="52">
                <a:moveTo>
                  <a:pt x="25" y="0"/>
                </a:moveTo>
                <a:lnTo>
                  <a:pt x="51" y="26"/>
                </a:lnTo>
                <a:lnTo>
                  <a:pt x="25" y="52"/>
                </a:lnTo>
                <a:lnTo>
                  <a:pt x="0" y="26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730680" y="4229280"/>
            <a:ext cx="90360" cy="9036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5"/>
                </a:lnTo>
                <a:lnTo>
                  <a:pt x="26" y="51"/>
                </a:lnTo>
                <a:lnTo>
                  <a:pt x="0" y="25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398680" y="5273640"/>
            <a:ext cx="90360" cy="9036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434960" y="5935680"/>
            <a:ext cx="90720" cy="9036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562120" y="4873680"/>
            <a:ext cx="90720" cy="9036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575160" y="5338800"/>
            <a:ext cx="90360" cy="9036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362400" y="4637160"/>
            <a:ext cx="90360" cy="9036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26"/>
                </a:lnTo>
                <a:lnTo>
                  <a:pt x="26" y="51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974960" y="5641920"/>
            <a:ext cx="90360" cy="9072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26"/>
                </a:lnTo>
                <a:lnTo>
                  <a:pt x="25" y="51"/>
                </a:lnTo>
                <a:lnTo>
                  <a:pt x="0" y="26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505240" y="5600880"/>
            <a:ext cx="90360" cy="9036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26"/>
                </a:lnTo>
                <a:lnTo>
                  <a:pt x="26" y="52"/>
                </a:lnTo>
                <a:lnTo>
                  <a:pt x="0" y="26"/>
                </a:lnTo>
                <a:lnTo>
                  <a:pt x="26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036960" y="5707080"/>
            <a:ext cx="90360" cy="9036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26"/>
                </a:lnTo>
                <a:lnTo>
                  <a:pt x="25" y="51"/>
                </a:lnTo>
                <a:lnTo>
                  <a:pt x="0" y="26"/>
                </a:lnTo>
                <a:lnTo>
                  <a:pt x="25" y="0"/>
                </a:lnTo>
                <a:close/>
              </a:path>
            </a:pathLst>
          </a:custGeom>
          <a:solidFill>
            <a:srgbClr val="9999ff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001880" y="5037120"/>
            <a:ext cx="2770200" cy="311040"/>
          </a:xfrm>
          <a:custGeom>
            <a:avLst/>
            <a:gdLst/>
            <a:ahLst/>
            <a:rect l="l" t="t" r="r" b="b"/>
            <a:pathLst>
              <a:path w="339" h="38">
                <a:moveTo>
                  <a:pt x="0" y="38"/>
                </a:moveTo>
                <a:lnTo>
                  <a:pt x="13" y="37"/>
                </a:lnTo>
                <a:lnTo>
                  <a:pt x="27" y="35"/>
                </a:lnTo>
                <a:lnTo>
                  <a:pt x="40" y="34"/>
                </a:lnTo>
                <a:lnTo>
                  <a:pt x="54" y="32"/>
                </a:lnTo>
                <a:lnTo>
                  <a:pt x="68" y="31"/>
                </a:lnTo>
                <a:lnTo>
                  <a:pt x="81" y="29"/>
                </a:lnTo>
                <a:lnTo>
                  <a:pt x="95" y="27"/>
                </a:lnTo>
                <a:lnTo>
                  <a:pt x="108" y="26"/>
                </a:lnTo>
                <a:lnTo>
                  <a:pt x="122" y="24"/>
                </a:lnTo>
                <a:lnTo>
                  <a:pt x="135" y="23"/>
                </a:lnTo>
                <a:lnTo>
                  <a:pt x="149" y="21"/>
                </a:lnTo>
                <a:lnTo>
                  <a:pt x="163" y="20"/>
                </a:lnTo>
                <a:lnTo>
                  <a:pt x="176" y="18"/>
                </a:lnTo>
                <a:lnTo>
                  <a:pt x="190" y="17"/>
                </a:lnTo>
                <a:lnTo>
                  <a:pt x="203" y="15"/>
                </a:lnTo>
                <a:lnTo>
                  <a:pt x="217" y="14"/>
                </a:lnTo>
                <a:lnTo>
                  <a:pt x="231" y="12"/>
                </a:lnTo>
                <a:lnTo>
                  <a:pt x="244" y="10"/>
                </a:lnTo>
                <a:lnTo>
                  <a:pt x="258" y="9"/>
                </a:lnTo>
                <a:lnTo>
                  <a:pt x="271" y="7"/>
                </a:lnTo>
                <a:lnTo>
                  <a:pt x="285" y="6"/>
                </a:lnTo>
                <a:lnTo>
                  <a:pt x="299" y="4"/>
                </a:lnTo>
                <a:lnTo>
                  <a:pt x="312" y="3"/>
                </a:lnTo>
                <a:lnTo>
                  <a:pt x="326" y="1"/>
                </a:lnTo>
                <a:lnTo>
                  <a:pt x="339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690840" y="62866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90840" y="600876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690840" y="57308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690840" y="545472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690840" y="517680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690840" y="488952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690840" y="461340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690840" y="43354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723960" y="40575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814320" y="4187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320840" y="4187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859040" y="4187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390760" y="4187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922480" y="4187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460680" y="4187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992400" y="4187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5078520" y="4137120"/>
            <a:ext cx="0" cy="2000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054760" y="61372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054760" y="58071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5054760" y="54705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5054760" y="514044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5054760" y="480384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5054760" y="447516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5054760" y="413712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5078520" y="4137120"/>
            <a:ext cx="3033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507852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V="1">
            <a:off x="558792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608976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V="1">
            <a:off x="659916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710100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flipV="1">
            <a:off x="761040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flipV="1">
            <a:off x="8112240" y="413712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6300720" y="4568760"/>
            <a:ext cx="90720" cy="90720"/>
          </a:xfrm>
          <a:custGeom>
            <a:avLst/>
            <a:gdLst/>
            <a:ahLst/>
            <a:rect l="l" t="t" r="r" b="b"/>
            <a:pathLst>
              <a:path w="49" h="49">
                <a:moveTo>
                  <a:pt x="25" y="0"/>
                </a:moveTo>
                <a:lnTo>
                  <a:pt x="49" y="49"/>
                </a:lnTo>
                <a:lnTo>
                  <a:pt x="0" y="49"/>
                </a:lnTo>
                <a:lnTo>
                  <a:pt x="25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5086440" y="4240080"/>
            <a:ext cx="90360" cy="90720"/>
          </a:xfrm>
          <a:custGeom>
            <a:avLst/>
            <a:gdLst/>
            <a:ahLst/>
            <a:rect l="l" t="t" r="r" b="b"/>
            <a:pathLst>
              <a:path w="49" h="49">
                <a:moveTo>
                  <a:pt x="24" y="0"/>
                </a:moveTo>
                <a:lnTo>
                  <a:pt x="49" y="49"/>
                </a:lnTo>
                <a:lnTo>
                  <a:pt x="0" y="49"/>
                </a:lnTo>
                <a:lnTo>
                  <a:pt x="24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5548320" y="5148360"/>
            <a:ext cx="90360" cy="90360"/>
          </a:xfrm>
          <a:custGeom>
            <a:avLst/>
            <a:gdLst/>
            <a:ahLst/>
            <a:rect l="l" t="t" r="r" b="b"/>
            <a:pathLst>
              <a:path w="49" h="50">
                <a:moveTo>
                  <a:pt x="25" y="0"/>
                </a:moveTo>
                <a:lnTo>
                  <a:pt x="49" y="50"/>
                </a:lnTo>
                <a:lnTo>
                  <a:pt x="0" y="50"/>
                </a:lnTo>
                <a:lnTo>
                  <a:pt x="25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6458040" y="4835520"/>
            <a:ext cx="90360" cy="90360"/>
          </a:xfrm>
          <a:custGeom>
            <a:avLst/>
            <a:gdLst/>
            <a:ahLst/>
            <a:rect l="l" t="t" r="r" b="b"/>
            <a:pathLst>
              <a:path w="49" h="49">
                <a:moveTo>
                  <a:pt x="24" y="0"/>
                </a:moveTo>
                <a:lnTo>
                  <a:pt x="49" y="49"/>
                </a:lnTo>
                <a:lnTo>
                  <a:pt x="0" y="49"/>
                </a:lnTo>
                <a:lnTo>
                  <a:pt x="24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7469280" y="5297400"/>
            <a:ext cx="90360" cy="90720"/>
          </a:xfrm>
          <a:custGeom>
            <a:avLst/>
            <a:gdLst/>
            <a:ahLst/>
            <a:rect l="l" t="t" r="r" b="b"/>
            <a:pathLst>
              <a:path w="49" h="50">
                <a:moveTo>
                  <a:pt x="24" y="0"/>
                </a:moveTo>
                <a:lnTo>
                  <a:pt x="49" y="50"/>
                </a:lnTo>
                <a:lnTo>
                  <a:pt x="0" y="50"/>
                </a:lnTo>
                <a:lnTo>
                  <a:pt x="24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5743440" y="5259240"/>
            <a:ext cx="90720" cy="90720"/>
          </a:xfrm>
          <a:custGeom>
            <a:avLst/>
            <a:gdLst/>
            <a:ahLst/>
            <a:rect l="l" t="t" r="r" b="b"/>
            <a:pathLst>
              <a:path w="50" h="49">
                <a:moveTo>
                  <a:pt x="25" y="0"/>
                </a:moveTo>
                <a:lnTo>
                  <a:pt x="50" y="49"/>
                </a:lnTo>
                <a:lnTo>
                  <a:pt x="0" y="49"/>
                </a:lnTo>
                <a:lnTo>
                  <a:pt x="25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6912000" y="5635800"/>
            <a:ext cx="90360" cy="90360"/>
          </a:xfrm>
          <a:custGeom>
            <a:avLst/>
            <a:gdLst/>
            <a:ahLst/>
            <a:rect l="l" t="t" r="r" b="b"/>
            <a:pathLst>
              <a:path w="49" h="49">
                <a:moveTo>
                  <a:pt x="25" y="0"/>
                </a:moveTo>
                <a:lnTo>
                  <a:pt x="49" y="49"/>
                </a:lnTo>
                <a:lnTo>
                  <a:pt x="0" y="49"/>
                </a:lnTo>
                <a:lnTo>
                  <a:pt x="25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6708600" y="5886360"/>
            <a:ext cx="90720" cy="90720"/>
          </a:xfrm>
          <a:custGeom>
            <a:avLst/>
            <a:gdLst/>
            <a:ahLst/>
            <a:rect l="l" t="t" r="r" b="b"/>
            <a:pathLst>
              <a:path w="49" h="49">
                <a:moveTo>
                  <a:pt x="24" y="0"/>
                </a:moveTo>
                <a:lnTo>
                  <a:pt x="49" y="49"/>
                </a:lnTo>
                <a:lnTo>
                  <a:pt x="0" y="49"/>
                </a:lnTo>
                <a:lnTo>
                  <a:pt x="24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6559560" y="5783400"/>
            <a:ext cx="90360" cy="90360"/>
          </a:xfrm>
          <a:custGeom>
            <a:avLst/>
            <a:gdLst/>
            <a:ahLst/>
            <a:rect l="l" t="t" r="r" b="b"/>
            <a:pathLst>
              <a:path w="49" h="50">
                <a:moveTo>
                  <a:pt x="25" y="0"/>
                </a:moveTo>
                <a:lnTo>
                  <a:pt x="49" y="50"/>
                </a:lnTo>
                <a:lnTo>
                  <a:pt x="0" y="50"/>
                </a:lnTo>
                <a:lnTo>
                  <a:pt x="25" y="0"/>
                </a:lnTo>
                <a:close/>
              </a:path>
            </a:pathLst>
          </a:custGeom>
          <a:solidFill>
            <a:srgbClr val="ff7c8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5124600" y="4678200"/>
            <a:ext cx="2382840" cy="1059120"/>
          </a:xfrm>
          <a:custGeom>
            <a:avLst/>
            <a:gdLst/>
            <a:ahLst/>
            <a:rect l="l" t="t" r="r" b="b"/>
            <a:pathLst>
              <a:path w="304" h="135">
                <a:moveTo>
                  <a:pt x="0" y="0"/>
                </a:moveTo>
                <a:lnTo>
                  <a:pt x="38" y="17"/>
                </a:lnTo>
                <a:lnTo>
                  <a:pt x="76" y="34"/>
                </a:lnTo>
                <a:lnTo>
                  <a:pt x="114" y="51"/>
                </a:lnTo>
                <a:lnTo>
                  <a:pt x="152" y="68"/>
                </a:lnTo>
                <a:lnTo>
                  <a:pt x="190" y="84"/>
                </a:lnTo>
                <a:lnTo>
                  <a:pt x="228" y="101"/>
                </a:lnTo>
                <a:lnTo>
                  <a:pt x="266" y="118"/>
                </a:lnTo>
                <a:lnTo>
                  <a:pt x="304" y="135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937400" y="60818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4937400" y="575316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4937400" y="541512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937400" y="50864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4937400" y="47498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4937400" y="441972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4968720" y="40831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5054760" y="4208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5540400" y="42084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6041880" y="42084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6551640" y="42084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7053120" y="42084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7562880" y="42084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8064360" y="42084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5064120" y="1371600"/>
            <a:ext cx="0" cy="2232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5040360" y="360360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5040360" y="323532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5040360" y="285912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5040360" y="24922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5040360" y="211608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5040360" y="174780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040360" y="1371600"/>
            <a:ext cx="23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5064120" y="1747800"/>
            <a:ext cx="3132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V="1">
            <a:off x="506412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flipV="1">
            <a:off x="558792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flipV="1">
            <a:off x="611028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663408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 flipV="1">
            <a:off x="714852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flipV="1">
            <a:off x="767232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V="1">
            <a:off x="8196120" y="17478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flipV="1">
            <a:off x="5334120" y="1443960"/>
            <a:ext cx="8244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flipV="1">
            <a:off x="7165800" y="1755000"/>
            <a:ext cx="81000" cy="81000"/>
          </a:xfrm>
          <a:custGeom>
            <a:avLst/>
            <a:gdLst/>
            <a:ahLst/>
            <a:rect l="l" t="t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 flipV="1">
            <a:off x="7688160" y="1763640"/>
            <a:ext cx="82800" cy="8280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 flipV="1">
            <a:off x="5284800" y="1779480"/>
            <a:ext cx="82440" cy="8280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 flipV="1">
            <a:off x="7631280" y="1869480"/>
            <a:ext cx="8244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flipV="1">
            <a:off x="6535800" y="1942560"/>
            <a:ext cx="8244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 flipV="1">
            <a:off x="5489640" y="2269440"/>
            <a:ext cx="81000" cy="8244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flipV="1">
            <a:off x="5595840" y="2409120"/>
            <a:ext cx="81000" cy="8244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flipV="1">
            <a:off x="5178600" y="2409120"/>
            <a:ext cx="8244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 flipV="1">
            <a:off x="5808600" y="2531520"/>
            <a:ext cx="81000" cy="8244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 flipV="1">
            <a:off x="5653080" y="2645640"/>
            <a:ext cx="81000" cy="8244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 flipV="1">
            <a:off x="5391000" y="2655000"/>
            <a:ext cx="8280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 flipV="1">
            <a:off x="5235480" y="2679120"/>
            <a:ext cx="8280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 flipV="1">
            <a:off x="5546880" y="2694960"/>
            <a:ext cx="80640" cy="82440"/>
          </a:xfrm>
          <a:custGeom>
            <a:avLst/>
            <a:gdLst/>
            <a:ahLst/>
            <a:rect l="l" t="t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 flipV="1">
            <a:off x="5129280" y="2704320"/>
            <a:ext cx="8244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 flipV="1">
            <a:off x="5235480" y="2728080"/>
            <a:ext cx="8280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 flipV="1">
            <a:off x="5178600" y="2777400"/>
            <a:ext cx="8244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 flipV="1">
            <a:off x="5489640" y="2867760"/>
            <a:ext cx="81000" cy="81000"/>
          </a:xfrm>
          <a:custGeom>
            <a:avLst/>
            <a:gdLst/>
            <a:ahLst/>
            <a:rect l="l" t="t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 flipV="1">
            <a:off x="5129280" y="2891880"/>
            <a:ext cx="8244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flipV="1">
            <a:off x="5129280" y="2891880"/>
            <a:ext cx="8244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flipV="1">
            <a:off x="5391000" y="2899800"/>
            <a:ext cx="8280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flipV="1">
            <a:off x="5235480" y="2899800"/>
            <a:ext cx="8280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 flipV="1">
            <a:off x="5235480" y="2915640"/>
            <a:ext cx="8280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 flipV="1">
            <a:off x="5178600" y="2925000"/>
            <a:ext cx="8244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5235480" y="2974320"/>
            <a:ext cx="8280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 flipV="1">
            <a:off x="5129280" y="3039480"/>
            <a:ext cx="82440" cy="81000"/>
          </a:xfrm>
          <a:custGeom>
            <a:avLst/>
            <a:gdLst/>
            <a:ahLst/>
            <a:rect l="l" t="t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 flipV="1">
            <a:off x="5235480" y="3234600"/>
            <a:ext cx="82800" cy="82440"/>
          </a:xfrm>
          <a:custGeom>
            <a:avLst/>
            <a:gdLst/>
            <a:ahLst/>
            <a:rect l="l" t="t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99cc00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5170320" y="1714680"/>
            <a:ext cx="2559240" cy="1071360"/>
          </a:xfrm>
          <a:custGeom>
            <a:avLst/>
            <a:gdLst/>
            <a:ahLst/>
            <a:rect l="l" t="t" r="r" b="b"/>
            <a:pathLst>
              <a:path w="313" h="131">
                <a:moveTo>
                  <a:pt x="0" y="131"/>
                </a:moveTo>
                <a:lnTo>
                  <a:pt x="12" y="126"/>
                </a:lnTo>
                <a:lnTo>
                  <a:pt x="24" y="121"/>
                </a:lnTo>
                <a:lnTo>
                  <a:pt x="36" y="116"/>
                </a:lnTo>
                <a:lnTo>
                  <a:pt x="48" y="111"/>
                </a:lnTo>
                <a:lnTo>
                  <a:pt x="60" y="106"/>
                </a:lnTo>
                <a:lnTo>
                  <a:pt x="72" y="100"/>
                </a:lnTo>
                <a:lnTo>
                  <a:pt x="84" y="95"/>
                </a:lnTo>
                <a:lnTo>
                  <a:pt x="96" y="90"/>
                </a:lnTo>
                <a:lnTo>
                  <a:pt x="108" y="85"/>
                </a:lnTo>
                <a:lnTo>
                  <a:pt x="120" y="80"/>
                </a:lnTo>
                <a:lnTo>
                  <a:pt x="132" y="75"/>
                </a:lnTo>
                <a:lnTo>
                  <a:pt x="144" y="70"/>
                </a:lnTo>
                <a:lnTo>
                  <a:pt x="156" y="65"/>
                </a:lnTo>
                <a:lnTo>
                  <a:pt x="168" y="60"/>
                </a:lnTo>
                <a:lnTo>
                  <a:pt x="180" y="55"/>
                </a:lnTo>
                <a:lnTo>
                  <a:pt x="192" y="50"/>
                </a:lnTo>
                <a:lnTo>
                  <a:pt x="204" y="45"/>
                </a:lnTo>
                <a:lnTo>
                  <a:pt x="216" y="40"/>
                </a:lnTo>
                <a:lnTo>
                  <a:pt x="228" y="35"/>
                </a:lnTo>
                <a:lnTo>
                  <a:pt x="240" y="30"/>
                </a:lnTo>
                <a:lnTo>
                  <a:pt x="252" y="25"/>
                </a:lnTo>
                <a:lnTo>
                  <a:pt x="264" y="20"/>
                </a:lnTo>
                <a:lnTo>
                  <a:pt x="276" y="15"/>
                </a:lnTo>
                <a:lnTo>
                  <a:pt x="288" y="10"/>
                </a:lnTo>
                <a:lnTo>
                  <a:pt x="301" y="5"/>
                </a:lnTo>
                <a:lnTo>
                  <a:pt x="313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4869720" y="3546360"/>
            <a:ext cx="127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916880" y="31780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4916880" y="280188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4916880" y="243540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916880" y="2058840"/>
            <a:ext cx="78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950000" y="16905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4950000" y="13143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5040360" y="1820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5538960" y="182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6060960" y="182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6585120" y="182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7099200" y="182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7623000" y="182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8147160" y="182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 Box 317"/>
          <p:cNvSpPr/>
          <p:nvPr/>
        </p:nvSpPr>
        <p:spPr>
          <a:xfrm>
            <a:off x="2822760" y="1150920"/>
            <a:ext cx="134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ge at report (yea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 Box 316"/>
          <p:cNvSpPr/>
          <p:nvPr/>
        </p:nvSpPr>
        <p:spPr>
          <a:xfrm rot="16200000">
            <a:off x="-299520" y="243540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317"/>
          <p:cNvSpPr/>
          <p:nvPr/>
        </p:nvSpPr>
        <p:spPr>
          <a:xfrm>
            <a:off x="6921720" y="1150920"/>
            <a:ext cx="134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ge at report (yea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 Box 316"/>
          <p:cNvSpPr/>
          <p:nvPr/>
        </p:nvSpPr>
        <p:spPr>
          <a:xfrm rot="16200000">
            <a:off x="3875040" y="256068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317"/>
          <p:cNvSpPr/>
          <p:nvPr/>
        </p:nvSpPr>
        <p:spPr>
          <a:xfrm>
            <a:off x="6921720" y="3819600"/>
            <a:ext cx="134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ge at report (yea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316"/>
          <p:cNvSpPr/>
          <p:nvPr/>
        </p:nvSpPr>
        <p:spPr>
          <a:xfrm rot="16200000">
            <a:off x="3875040" y="507708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317"/>
          <p:cNvSpPr/>
          <p:nvPr/>
        </p:nvSpPr>
        <p:spPr>
          <a:xfrm>
            <a:off x="2822760" y="3819600"/>
            <a:ext cx="134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ge at report (yea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316"/>
          <p:cNvSpPr/>
          <p:nvPr/>
        </p:nvSpPr>
        <p:spPr>
          <a:xfrm rot="16200000">
            <a:off x="-299520" y="510408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2T12:13:04Z</dcterms:created>
  <dc:creator>tvulliamy</dc:creator>
  <dc:description/>
  <dc:language>en-US</dc:language>
  <cp:lastModifiedBy>tvulliamy</cp:lastModifiedBy>
  <dcterms:modified xsi:type="dcterms:W3CDTF">2011-04-12T12:13:15Z</dcterms:modified>
  <cp:revision>1</cp:revision>
  <dc:subject/>
  <dc:title>Slide 1</dc:title>
</cp:coreProperties>
</file>